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98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15/09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323528" y="44624"/>
            <a:ext cx="712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6: Contigs scaffolded with </a:t>
            </a:r>
            <a:r>
              <a:rPr lang="en-US" dirty="0" err="1"/>
              <a:t>Sanyueli</a:t>
            </a:r>
            <a:r>
              <a:rPr lang="en-US" dirty="0"/>
              <a:t> MYB10 regio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1122D38-2F6C-4E15-8071-6CD9F91CA2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2080" y="518160"/>
            <a:ext cx="6339840" cy="633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32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44624"/>
            <a:ext cx="8424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6: Contigs scaffolded with Zhongli-1 MYB10 reg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DE04C3-EB67-4DA4-A1E4-45C444F524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2080" y="518160"/>
            <a:ext cx="6339840" cy="633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261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44624"/>
            <a:ext cx="8064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6: Contigs scaffolded with Zhongli-2 MYB10 reg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186890-1B9E-4692-B817-5B237C6250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2080" y="518160"/>
            <a:ext cx="6339840" cy="633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65323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30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Fiol, Arnau</cp:lastModifiedBy>
  <cp:revision>1</cp:revision>
  <dcterms:created xsi:type="dcterms:W3CDTF">2021-09-01T14:55:02Z</dcterms:created>
  <dcterms:modified xsi:type="dcterms:W3CDTF">2021-09-15T10:49:58Z</dcterms:modified>
</cp:coreProperties>
</file>